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7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513262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80499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41531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30036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25463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888776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76835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35626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77224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48092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56322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047EE-1919-4904-A23A-EFB7E074647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D89B4-5A28-4F9D-99E6-FFB10CA6DA1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77540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2141202" y="2195537"/>
            <a:ext cx="5208942" cy="1959413"/>
            <a:chOff x="2141202" y="2195537"/>
            <a:chExt cx="5208942" cy="1959413"/>
          </a:xfrm>
        </p:grpSpPr>
        <p:sp>
          <p:nvSpPr>
            <p:cNvPr id="5" name="TextBox 4"/>
            <p:cNvSpPr txBox="1"/>
            <p:nvPr/>
          </p:nvSpPr>
          <p:spPr>
            <a:xfrm>
              <a:off x="6524244" y="2608737"/>
              <a:ext cx="5087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526612" y="2974411"/>
              <a:ext cx="5040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513390" y="3271131"/>
              <a:ext cx="7033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C3-I</a:t>
              </a:r>
            </a:p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C3-II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524244" y="3786654"/>
              <a:ext cx="825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958132" y="2195537"/>
              <a:ext cx="39790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oxia        starvation       hypoxia          H/S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Connector 9"/>
            <p:cNvCxnSpPr/>
            <p:nvPr/>
          </p:nvCxnSpPr>
          <p:spPr>
            <a:xfrm flipH="1">
              <a:off x="2680198" y="2632203"/>
              <a:ext cx="1253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>
              <a:off x="2693736" y="2995290"/>
              <a:ext cx="1253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>
              <a:off x="2672964" y="4016451"/>
              <a:ext cx="1253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2141202" y="2289655"/>
              <a:ext cx="5202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338920" y="2493703"/>
              <a:ext cx="356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330078" y="2856790"/>
              <a:ext cx="3636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330079" y="3877951"/>
              <a:ext cx="3636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 flipH="1">
              <a:off x="2680198" y="3419486"/>
              <a:ext cx="1253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2316541" y="3313687"/>
              <a:ext cx="356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Straight Connector 18"/>
            <p:cNvCxnSpPr/>
            <p:nvPr/>
          </p:nvCxnSpPr>
          <p:spPr>
            <a:xfrm flipH="1">
              <a:off x="2672964" y="3590686"/>
              <a:ext cx="1253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2323775" y="3509655"/>
              <a:ext cx="4356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uk-UA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Picture 2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2349" y="3786654"/>
              <a:ext cx="3701895" cy="3302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2348" y="3329635"/>
              <a:ext cx="3690048" cy="3600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2349" y="2974411"/>
              <a:ext cx="3686091" cy="2806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8" name="Picture 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4248" y="2591394"/>
              <a:ext cx="3684192" cy="2653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0" name="TextBox 29"/>
          <p:cNvSpPr txBox="1"/>
          <p:nvPr/>
        </p:nvSpPr>
        <p:spPr>
          <a:xfrm>
            <a:off x="0" y="0"/>
            <a:ext cx="73501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2:  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Stress inhibits autophagy in primary stromal cells.</a:t>
            </a:r>
            <a:endParaRPr lang="de-A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83568" y="4473986"/>
            <a:ext cx="80648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Legend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ot show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hibition of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C3 (autophagy marke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p53 and p2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y prolonged (42 days) stress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imar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oma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ells. 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2470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sak Zvenyslava</dc:creator>
  <cp:lastModifiedBy>Husak Zvenyslava</cp:lastModifiedBy>
  <cp:revision>5</cp:revision>
  <dcterms:created xsi:type="dcterms:W3CDTF">2016-09-23T14:01:57Z</dcterms:created>
  <dcterms:modified xsi:type="dcterms:W3CDTF">2016-10-19T12:05:08Z</dcterms:modified>
</cp:coreProperties>
</file>